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38" saveSubsetFonts="1" autoCompressPictures="0">
  <p:sldMasterIdLst>
    <p:sldMasterId id="2147483684" r:id="rId1"/>
  </p:sldMasterIdLst>
  <p:notesMasterIdLst>
    <p:notesMasterId r:id="rId4"/>
  </p:notesMasterIdLst>
  <p:sldIdLst>
    <p:sldId id="289" r:id="rId2"/>
    <p:sldId id="290" r:id="rId3"/>
  </p:sldIdLst>
  <p:sldSz cx="6300788" cy="82073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ppenberg" initials="C" lastIdx="2" clrIdx="0">
    <p:extLst>
      <p:ext uri="{19B8F6BF-5375-455C-9EA6-DF929625EA0E}">
        <p15:presenceInfo xmlns:p15="http://schemas.microsoft.com/office/powerpoint/2012/main" userId="Cappenberg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>
    <p:restoredLeft sz="0" autoAdjust="0"/>
    <p:restoredTop sz="92138" autoAdjust="0"/>
  </p:normalViewPr>
  <p:slideViewPr>
    <p:cSldViewPr snapToGrid="0">
      <p:cViewPr varScale="1">
        <p:scale>
          <a:sx n="68" d="100"/>
          <a:sy n="68" d="100"/>
        </p:scale>
        <p:origin x="3034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FDEA036-15BC-4B48-BE03-AAB437B05833}" type="datetimeFigureOut">
              <a:rPr lang="en-US" smtClean="0"/>
              <a:t>12/23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4725" y="1143000"/>
            <a:ext cx="2368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5E7D2CC-C2F8-A64D-93E3-F2E64EE5B16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2984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1pPr>
    <a:lvl2pPr marL="395661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2pPr>
    <a:lvl3pPr marL="791322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3pPr>
    <a:lvl4pPr marL="1186983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4pPr>
    <a:lvl5pPr marL="1582644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5pPr>
    <a:lvl6pPr marL="1978304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6pPr>
    <a:lvl7pPr marL="2373965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7pPr>
    <a:lvl8pPr marL="2769626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8pPr>
    <a:lvl9pPr marL="3165287" algn="l" defTabSz="791322" rtl="0" eaLnBrk="1" latinLnBrk="0" hangingPunct="1">
      <a:defRPr sz="103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751735F-E8D0-225D-3D39-CF741CE7C0D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169485E1-1D35-C1F5-6B96-458F1B66E97B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91EEE3C4-3C55-8F1C-E3DE-9867359EA7C8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CE25D3-6DDF-3572-D0EF-0B0E682E02B5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3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693777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CCC5EB-E447-115A-DF36-05FE113E09A9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>
            <a:extLst>
              <a:ext uri="{FF2B5EF4-FFF2-40B4-BE49-F238E27FC236}">
                <a16:creationId xmlns:a16="http://schemas.microsoft.com/office/drawing/2014/main" id="{084B0231-55BA-B150-405F-3869D9A627DE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>
          <a:xfrm>
            <a:off x="2244725" y="1143000"/>
            <a:ext cx="2368550" cy="3086100"/>
          </a:xfrm>
        </p:spPr>
      </p:sp>
      <p:sp>
        <p:nvSpPr>
          <p:cNvPr id="3" name="Notes Placeholder 2">
            <a:extLst>
              <a:ext uri="{FF2B5EF4-FFF2-40B4-BE49-F238E27FC236}">
                <a16:creationId xmlns:a16="http://schemas.microsoft.com/office/drawing/2014/main" id="{A854C791-3730-66B1-5F14-E581D8E53EA4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4789EB-2E13-EFB7-830B-4126CD05FA42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5E7D2CC-C2F8-A64D-93E3-F2E64EE5B16E}" type="slidenum">
              <a:rPr lang="en-US" smtClean="0"/>
              <a:t>3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245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72559" y="1343199"/>
            <a:ext cx="5355670" cy="2857382"/>
          </a:xfrm>
        </p:spPr>
        <p:txBody>
          <a:bodyPr anchor="b"/>
          <a:lstStyle>
            <a:lvl1pPr algn="ctr"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4310772"/>
            <a:ext cx="4725591" cy="1981549"/>
          </a:xfrm>
        </p:spPr>
        <p:txBody>
          <a:bodyPr/>
          <a:lstStyle>
            <a:lvl1pPr marL="0" indent="0" algn="ctr">
              <a:buNone/>
              <a:defRPr sz="1654"/>
            </a:lvl1pPr>
            <a:lvl2pPr marL="315057" indent="0" algn="ctr">
              <a:buNone/>
              <a:defRPr sz="1378"/>
            </a:lvl2pPr>
            <a:lvl3pPr marL="630113" indent="0" algn="ctr">
              <a:buNone/>
              <a:defRPr sz="1240"/>
            </a:lvl3pPr>
            <a:lvl4pPr marL="945170" indent="0" algn="ctr">
              <a:buNone/>
              <a:defRPr sz="1103"/>
            </a:lvl4pPr>
            <a:lvl5pPr marL="1260226" indent="0" algn="ctr">
              <a:buNone/>
              <a:defRPr sz="1103"/>
            </a:lvl5pPr>
            <a:lvl6pPr marL="1575283" indent="0" algn="ctr">
              <a:buNone/>
              <a:defRPr sz="1103"/>
            </a:lvl6pPr>
            <a:lvl7pPr marL="1890339" indent="0" algn="ctr">
              <a:buNone/>
              <a:defRPr sz="1103"/>
            </a:lvl7pPr>
            <a:lvl8pPr marL="2205396" indent="0" algn="ctr">
              <a:buNone/>
              <a:defRPr sz="1103"/>
            </a:lvl8pPr>
            <a:lvl9pPr marL="2520452" indent="0" algn="ctr">
              <a:buNone/>
              <a:defRPr sz="1103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5933AB-3E51-4445-A1CF-2ADC5E3954CB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906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3B227C-308B-6849-8B9D-8396633A9746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188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436967"/>
            <a:ext cx="1358607" cy="6955371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80" y="436967"/>
            <a:ext cx="3997062" cy="6955371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1D43AB-BC5C-0E4A-8281-D0B64264A8CE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3420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68506-30DD-1840-9335-35199E9BEFE5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67384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8" y="2046147"/>
            <a:ext cx="5434430" cy="3414039"/>
          </a:xfrm>
        </p:spPr>
        <p:txBody>
          <a:bodyPr anchor="b"/>
          <a:lstStyle>
            <a:lvl1pPr>
              <a:defRPr sz="413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8" y="5492484"/>
            <a:ext cx="5434430" cy="1795363"/>
          </a:xfrm>
        </p:spPr>
        <p:txBody>
          <a:bodyPr/>
          <a:lstStyle>
            <a:lvl1pPr marL="0" indent="0">
              <a:buNone/>
              <a:defRPr sz="1654">
                <a:solidFill>
                  <a:schemeClr val="tx1"/>
                </a:solidFill>
              </a:defRPr>
            </a:lvl1pPr>
            <a:lvl2pPr marL="315057" indent="0">
              <a:buNone/>
              <a:defRPr sz="1378">
                <a:solidFill>
                  <a:schemeClr val="tx1">
                    <a:tint val="75000"/>
                  </a:schemeClr>
                </a:solidFill>
              </a:defRPr>
            </a:lvl2pPr>
            <a:lvl3pPr marL="630113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3pPr>
            <a:lvl4pPr marL="945170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4pPr>
            <a:lvl5pPr marL="126022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5pPr>
            <a:lvl6pPr marL="1575283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6pPr>
            <a:lvl7pPr marL="1890339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7pPr>
            <a:lvl8pPr marL="2205396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8pPr>
            <a:lvl9pPr marL="2520452" indent="0">
              <a:buNone/>
              <a:defRPr sz="11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00BBC7-D874-9342-BA92-7CBABE999B84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470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2184834"/>
            <a:ext cx="2677835" cy="52075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B32204-AAAF-1C42-9058-FAC7D190360F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51741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436968"/>
            <a:ext cx="5434430" cy="1586380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1" y="2011948"/>
            <a:ext cx="2665528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1" y="2997972"/>
            <a:ext cx="2665528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2011948"/>
            <a:ext cx="2678656" cy="986024"/>
          </a:xfrm>
        </p:spPr>
        <p:txBody>
          <a:bodyPr anchor="b"/>
          <a:lstStyle>
            <a:lvl1pPr marL="0" indent="0">
              <a:buNone/>
              <a:defRPr sz="1654" b="1"/>
            </a:lvl1pPr>
            <a:lvl2pPr marL="315057" indent="0">
              <a:buNone/>
              <a:defRPr sz="1378" b="1"/>
            </a:lvl2pPr>
            <a:lvl3pPr marL="630113" indent="0">
              <a:buNone/>
              <a:defRPr sz="1240" b="1"/>
            </a:lvl3pPr>
            <a:lvl4pPr marL="945170" indent="0">
              <a:buNone/>
              <a:defRPr sz="1103" b="1"/>
            </a:lvl4pPr>
            <a:lvl5pPr marL="1260226" indent="0">
              <a:buNone/>
              <a:defRPr sz="1103" b="1"/>
            </a:lvl5pPr>
            <a:lvl6pPr marL="1575283" indent="0">
              <a:buNone/>
              <a:defRPr sz="1103" b="1"/>
            </a:lvl6pPr>
            <a:lvl7pPr marL="1890339" indent="0">
              <a:buNone/>
              <a:defRPr sz="1103" b="1"/>
            </a:lvl7pPr>
            <a:lvl8pPr marL="2205396" indent="0">
              <a:buNone/>
              <a:defRPr sz="1103" b="1"/>
            </a:lvl8pPr>
            <a:lvl9pPr marL="2520452" indent="0">
              <a:buNone/>
              <a:defRPr sz="1103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2997972"/>
            <a:ext cx="2678656" cy="4409565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832EC-4446-4244-8EFE-AC02BF8296C6}" type="datetime1">
              <a:rPr lang="de-DE" smtClean="0"/>
              <a:t>23.12.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44088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FED91BE-5A90-C642-9C1B-B5E2A0553440}" type="datetime1">
              <a:rPr lang="de-DE" smtClean="0"/>
              <a:t>23.12.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7565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C11584-0253-0849-8994-5C77550FC46D}" type="datetime1">
              <a:rPr lang="de-DE" smtClean="0"/>
              <a:t>23.12.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4295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1181712"/>
            <a:ext cx="3189774" cy="5832556"/>
          </a:xfrm>
        </p:spPr>
        <p:txBody>
          <a:bodyPr/>
          <a:lstStyle>
            <a:lvl1pPr>
              <a:defRPr sz="2205"/>
            </a:lvl1pPr>
            <a:lvl2pPr>
              <a:defRPr sz="1929"/>
            </a:lvl2pPr>
            <a:lvl3pPr>
              <a:defRPr sz="1654"/>
            </a:lvl3pPr>
            <a:lvl4pPr>
              <a:defRPr sz="1378"/>
            </a:lvl4pPr>
            <a:lvl5pPr>
              <a:defRPr sz="1378"/>
            </a:lvl5pPr>
            <a:lvl6pPr>
              <a:defRPr sz="1378"/>
            </a:lvl6pPr>
            <a:lvl7pPr>
              <a:defRPr sz="1378"/>
            </a:lvl7pPr>
            <a:lvl8pPr>
              <a:defRPr sz="1378"/>
            </a:lvl8pPr>
            <a:lvl9pPr>
              <a:defRPr sz="1378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4D6EF-E6DD-CA4B-9960-C5DE565EFD36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6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547158"/>
            <a:ext cx="2032168" cy="1915054"/>
          </a:xfrm>
        </p:spPr>
        <p:txBody>
          <a:bodyPr anchor="b"/>
          <a:lstStyle>
            <a:lvl1pPr>
              <a:defRPr sz="2205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1181712"/>
            <a:ext cx="3189774" cy="5832556"/>
          </a:xfrm>
        </p:spPr>
        <p:txBody>
          <a:bodyPr anchor="t"/>
          <a:lstStyle>
            <a:lvl1pPr marL="0" indent="0">
              <a:buNone/>
              <a:defRPr sz="2205"/>
            </a:lvl1pPr>
            <a:lvl2pPr marL="315057" indent="0">
              <a:buNone/>
              <a:defRPr sz="1929"/>
            </a:lvl2pPr>
            <a:lvl3pPr marL="630113" indent="0">
              <a:buNone/>
              <a:defRPr sz="1654"/>
            </a:lvl3pPr>
            <a:lvl4pPr marL="945170" indent="0">
              <a:buNone/>
              <a:defRPr sz="1378"/>
            </a:lvl4pPr>
            <a:lvl5pPr marL="1260226" indent="0">
              <a:buNone/>
              <a:defRPr sz="1378"/>
            </a:lvl5pPr>
            <a:lvl6pPr marL="1575283" indent="0">
              <a:buNone/>
              <a:defRPr sz="1378"/>
            </a:lvl6pPr>
            <a:lvl7pPr marL="1890339" indent="0">
              <a:buNone/>
              <a:defRPr sz="1378"/>
            </a:lvl7pPr>
            <a:lvl8pPr marL="2205396" indent="0">
              <a:buNone/>
              <a:defRPr sz="1378"/>
            </a:lvl8pPr>
            <a:lvl9pPr marL="2520452" indent="0">
              <a:buNone/>
              <a:defRPr sz="1378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2462213"/>
            <a:ext cx="2032168" cy="4561553"/>
          </a:xfrm>
        </p:spPr>
        <p:txBody>
          <a:bodyPr/>
          <a:lstStyle>
            <a:lvl1pPr marL="0" indent="0">
              <a:buNone/>
              <a:defRPr sz="1103"/>
            </a:lvl1pPr>
            <a:lvl2pPr marL="315057" indent="0">
              <a:buNone/>
              <a:defRPr sz="965"/>
            </a:lvl2pPr>
            <a:lvl3pPr marL="630113" indent="0">
              <a:buNone/>
              <a:defRPr sz="827"/>
            </a:lvl3pPr>
            <a:lvl4pPr marL="945170" indent="0">
              <a:buNone/>
              <a:defRPr sz="689"/>
            </a:lvl4pPr>
            <a:lvl5pPr marL="1260226" indent="0">
              <a:buNone/>
              <a:defRPr sz="689"/>
            </a:lvl5pPr>
            <a:lvl6pPr marL="1575283" indent="0">
              <a:buNone/>
              <a:defRPr sz="689"/>
            </a:lvl6pPr>
            <a:lvl7pPr marL="1890339" indent="0">
              <a:buNone/>
              <a:defRPr sz="689"/>
            </a:lvl7pPr>
            <a:lvl8pPr marL="2205396" indent="0">
              <a:buNone/>
              <a:defRPr sz="689"/>
            </a:lvl8pPr>
            <a:lvl9pPr marL="2520452" indent="0">
              <a:buNone/>
              <a:defRPr sz="68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9989163-5445-AE42-B8FD-E7F7346026DA}" type="datetime1">
              <a:rPr lang="de-DE" smtClean="0"/>
              <a:t>23.12.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50749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436968"/>
            <a:ext cx="5434430" cy="158638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2184834"/>
            <a:ext cx="5434430" cy="520750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DDEBC2-67ED-884E-A821-17FB42EDB145}" type="datetime1">
              <a:rPr lang="de-DE" smtClean="0"/>
              <a:t>23.12.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7607022"/>
            <a:ext cx="2126516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7607022"/>
            <a:ext cx="1417677" cy="4369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9684F8-57A1-794A-910E-5401E73F481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7942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hf hdr="0" ftr="0" dt="0"/>
  <p:txStyles>
    <p:titleStyle>
      <a:lvl1pPr algn="l" defTabSz="630113" rtl="0" eaLnBrk="1" latinLnBrk="0" hangingPunct="1">
        <a:lnSpc>
          <a:spcPct val="90000"/>
        </a:lnSpc>
        <a:spcBef>
          <a:spcPct val="0"/>
        </a:spcBef>
        <a:buNone/>
        <a:defRPr sz="303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7528" indent="-157528" algn="l" defTabSz="63011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1929" kern="1200">
          <a:solidFill>
            <a:schemeClr val="tx1"/>
          </a:solidFill>
          <a:latin typeface="+mn-lt"/>
          <a:ea typeface="+mn-ea"/>
          <a:cs typeface="+mn-cs"/>
        </a:defRPr>
      </a:lvl1pPr>
      <a:lvl2pPr marL="472585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654" kern="1200">
          <a:solidFill>
            <a:schemeClr val="tx1"/>
          </a:solidFill>
          <a:latin typeface="+mn-lt"/>
          <a:ea typeface="+mn-ea"/>
          <a:cs typeface="+mn-cs"/>
        </a:defRPr>
      </a:lvl2pPr>
      <a:lvl3pPr marL="78764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378" kern="1200">
          <a:solidFill>
            <a:schemeClr val="tx1"/>
          </a:solidFill>
          <a:latin typeface="+mn-lt"/>
          <a:ea typeface="+mn-ea"/>
          <a:cs typeface="+mn-cs"/>
        </a:defRPr>
      </a:lvl3pPr>
      <a:lvl4pPr marL="1102698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41775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732811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2047867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362924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677980" indent="-157528" algn="l" defTabSz="630113" rtl="0" eaLnBrk="1" latinLnBrk="0" hangingPunct="1">
        <a:lnSpc>
          <a:spcPct val="90000"/>
        </a:lnSpc>
        <a:spcBef>
          <a:spcPts val="345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1pPr>
      <a:lvl2pPr marL="315057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63011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3pPr>
      <a:lvl4pPr marL="945170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4pPr>
      <a:lvl5pPr marL="126022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5pPr>
      <a:lvl6pPr marL="1575283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6pPr>
      <a:lvl7pPr marL="1890339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7pPr>
      <a:lvl8pPr marL="2205396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8pPr>
      <a:lvl9pPr marL="2520452" algn="l" defTabSz="630113" rtl="0" eaLnBrk="1" latinLnBrk="0" hangingPunct="1">
        <a:defRPr sz="1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tiff"/><Relationship Id="rId18" Type="http://schemas.openxmlformats.org/officeDocument/2006/relationships/image" Target="../media/image16.tiff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tiff"/><Relationship Id="rId17" Type="http://schemas.openxmlformats.org/officeDocument/2006/relationships/image" Target="../media/image15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tiff"/><Relationship Id="rId10" Type="http://schemas.openxmlformats.org/officeDocument/2006/relationships/image" Target="../media/image8.png"/><Relationship Id="rId19" Type="http://schemas.openxmlformats.org/officeDocument/2006/relationships/image" Target="../media/image17.tiff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tif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C2D68B9-B410-9816-44FF-C4A809D0661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A0C2C1-3A2B-B87B-4379-B9FD074E23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6795" y="128415"/>
            <a:ext cx="4900750" cy="388279"/>
          </a:xfrm>
        </p:spPr>
        <p:txBody>
          <a:bodyPr>
            <a:normAutofit fontScale="90000"/>
          </a:bodyPr>
          <a:lstStyle/>
          <a:p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Supplemental </a:t>
            </a:r>
            <a:r>
              <a:rPr lang="en-US" sz="149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1. Expression of Ca</a:t>
            </a:r>
            <a:r>
              <a:rPr lang="en-US" sz="1491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US" sz="1491" dirty="0">
                <a:latin typeface="Arial" panose="020B0604020202020204" pitchFamily="34" charset="0"/>
                <a:cs typeface="Arial" panose="020B0604020202020204" pitchFamily="34" charset="0"/>
              </a:rPr>
              <a:t> isoforms in neutrophils</a:t>
            </a:r>
            <a:endParaRPr lang="en-US" sz="1491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F2218DD-B6FC-BC83-75AF-26FE5E77425B}"/>
              </a:ext>
            </a:extLst>
          </p:cNvPr>
          <p:cNvSpPr txBox="1"/>
          <p:nvPr/>
        </p:nvSpPr>
        <p:spPr>
          <a:xfrm>
            <a:off x="348502" y="612762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EEC37EF-FB41-D193-99EE-F5135752110A}"/>
              </a:ext>
            </a:extLst>
          </p:cNvPr>
          <p:cNvSpPr txBox="1"/>
          <p:nvPr/>
        </p:nvSpPr>
        <p:spPr>
          <a:xfrm>
            <a:off x="1607372" y="612762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138300A-61C8-E4F3-665A-8C21B5F25203}"/>
              </a:ext>
            </a:extLst>
          </p:cNvPr>
          <p:cNvSpPr txBox="1"/>
          <p:nvPr/>
        </p:nvSpPr>
        <p:spPr>
          <a:xfrm>
            <a:off x="3003939" y="612762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1FFF488-1737-684F-FD5F-4FB2D17DE35E}"/>
              </a:ext>
            </a:extLst>
          </p:cNvPr>
          <p:cNvSpPr txBox="1"/>
          <p:nvPr/>
        </p:nvSpPr>
        <p:spPr>
          <a:xfrm>
            <a:off x="4115929" y="612762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E538FD73-F6FA-DD0E-34E0-308DA1F19475}"/>
              </a:ext>
            </a:extLst>
          </p:cNvPr>
          <p:cNvSpPr txBox="1"/>
          <p:nvPr/>
        </p:nvSpPr>
        <p:spPr>
          <a:xfrm>
            <a:off x="304099" y="1602881"/>
            <a:ext cx="28405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EDBD5C7-7F26-D0D2-70E9-8B070881569A}"/>
              </a:ext>
            </a:extLst>
          </p:cNvPr>
          <p:cNvSpPr txBox="1"/>
          <p:nvPr/>
        </p:nvSpPr>
        <p:spPr>
          <a:xfrm>
            <a:off x="1576364" y="1600552"/>
            <a:ext cx="27603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A05796BF-CFD4-6992-13CC-08DA20B71BDC}"/>
              </a:ext>
            </a:extLst>
          </p:cNvPr>
          <p:cNvSpPr txBox="1"/>
          <p:nvPr/>
        </p:nvSpPr>
        <p:spPr>
          <a:xfrm>
            <a:off x="4110202" y="1623692"/>
            <a:ext cx="29206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601DB54-89C1-BDF2-3E6E-3671D0F79F9B}"/>
              </a:ext>
            </a:extLst>
          </p:cNvPr>
          <p:cNvSpPr txBox="1"/>
          <p:nvPr/>
        </p:nvSpPr>
        <p:spPr>
          <a:xfrm>
            <a:off x="2960204" y="1617989"/>
            <a:ext cx="30008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37D5C71-5A9B-F3DA-2ED5-10C92BF99C26}"/>
              </a:ext>
            </a:extLst>
          </p:cNvPr>
          <p:cNvSpPr txBox="1"/>
          <p:nvPr/>
        </p:nvSpPr>
        <p:spPr>
          <a:xfrm>
            <a:off x="4496461" y="2935937"/>
            <a:ext cx="27603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D319D5D-B4E4-051E-E0F3-D57CBCBE7F5E}"/>
              </a:ext>
            </a:extLst>
          </p:cNvPr>
          <p:cNvSpPr txBox="1"/>
          <p:nvPr/>
        </p:nvSpPr>
        <p:spPr>
          <a:xfrm>
            <a:off x="343196" y="2925260"/>
            <a:ext cx="226344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F8FC5AB-FC48-6F81-F748-B08C2F86295D}"/>
              </a:ext>
            </a:extLst>
          </p:cNvPr>
          <p:cNvSpPr txBox="1"/>
          <p:nvPr/>
        </p:nvSpPr>
        <p:spPr>
          <a:xfrm>
            <a:off x="1869614" y="2954395"/>
            <a:ext cx="26802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4449E0-9FDF-B272-326E-07A334BA13D1}"/>
              </a:ext>
            </a:extLst>
          </p:cNvPr>
          <p:cNvSpPr txBox="1"/>
          <p:nvPr/>
        </p:nvSpPr>
        <p:spPr>
          <a:xfrm>
            <a:off x="3474693" y="2938755"/>
            <a:ext cx="30008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51499A55-9755-3E09-E774-81DB940B0266}"/>
              </a:ext>
            </a:extLst>
          </p:cNvPr>
          <p:cNvSpPr/>
          <p:nvPr/>
        </p:nvSpPr>
        <p:spPr bwMode="auto">
          <a:xfrm rot="19168954">
            <a:off x="402269" y="670973"/>
            <a:ext cx="868239" cy="168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97" dirty="0">
                <a:latin typeface="Arial" panose="020B0604020202020204" pitchFamily="34" charset="0"/>
                <a:ea typeface="Harding Text Web Regular" pitchFamily="2" charset="0"/>
                <a:cs typeface="Arial" panose="020B0604020202020204" pitchFamily="34" charset="0"/>
              </a:rPr>
              <a:t>Control</a:t>
            </a:r>
          </a:p>
        </p:txBody>
      </p:sp>
      <p:sp>
        <p:nvSpPr>
          <p:cNvPr id="58" name="Rectangle 57">
            <a:extLst>
              <a:ext uri="{FF2B5EF4-FFF2-40B4-BE49-F238E27FC236}">
                <a16:creationId xmlns:a16="http://schemas.microsoft.com/office/drawing/2014/main" id="{BE007C9C-F8EA-23EF-4BEB-DA9213544207}"/>
              </a:ext>
            </a:extLst>
          </p:cNvPr>
          <p:cNvSpPr/>
          <p:nvPr/>
        </p:nvSpPr>
        <p:spPr bwMode="auto">
          <a:xfrm rot="19168954">
            <a:off x="651815" y="683415"/>
            <a:ext cx="844606" cy="168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97" dirty="0">
                <a:latin typeface="Arial" panose="020B0604020202020204" pitchFamily="34" charset="0"/>
                <a:ea typeface="Harding Text Web Regular" pitchFamily="2" charset="0"/>
                <a:cs typeface="Arial" panose="020B0604020202020204" pitchFamily="34" charset="0"/>
              </a:rPr>
              <a:t>STIM1-KO</a:t>
            </a:r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CFC37BF4-226E-7EC4-D964-6932BBE8DAE9}"/>
              </a:ext>
            </a:extLst>
          </p:cNvPr>
          <p:cNvSpPr/>
          <p:nvPr/>
        </p:nvSpPr>
        <p:spPr bwMode="auto">
          <a:xfrm>
            <a:off x="1015551" y="1045155"/>
            <a:ext cx="403279" cy="168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97" dirty="0">
                <a:latin typeface="Arial" panose="020B0604020202020204" pitchFamily="34" charset="0"/>
                <a:ea typeface="Harding Text Web Regular" pitchFamily="2" charset="0"/>
                <a:cs typeface="Arial" panose="020B0604020202020204" pitchFamily="34" charset="0"/>
              </a:rPr>
              <a:t>STIM1</a:t>
            </a:r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E4AB8227-5ED1-FA34-B0BC-693F3CEED9F5}"/>
              </a:ext>
            </a:extLst>
          </p:cNvPr>
          <p:cNvSpPr/>
          <p:nvPr/>
        </p:nvSpPr>
        <p:spPr bwMode="auto">
          <a:xfrm>
            <a:off x="1023019" y="1280360"/>
            <a:ext cx="449709" cy="1688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497" dirty="0">
                <a:latin typeface="Arial" panose="020B0604020202020204" pitchFamily="34" charset="0"/>
                <a:ea typeface="Harding Text Web Regular" pitchFamily="2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B88CB48E-7ACD-D240-A560-6E095BD3EF49}"/>
              </a:ext>
            </a:extLst>
          </p:cNvPr>
          <p:cNvSpPr txBox="1"/>
          <p:nvPr/>
        </p:nvSpPr>
        <p:spPr>
          <a:xfrm>
            <a:off x="312746" y="4142251"/>
            <a:ext cx="308098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82C0974-095B-EB3C-3DBB-C94E20BADBE8}"/>
              </a:ext>
            </a:extLst>
          </p:cNvPr>
          <p:cNvSpPr txBox="1"/>
          <p:nvPr/>
        </p:nvSpPr>
        <p:spPr>
          <a:xfrm>
            <a:off x="1820472" y="4186921"/>
            <a:ext cx="300082" cy="2708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6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grpSp>
        <p:nvGrpSpPr>
          <p:cNvPr id="35" name="Group 34">
            <a:extLst>
              <a:ext uri="{FF2B5EF4-FFF2-40B4-BE49-F238E27FC236}">
                <a16:creationId xmlns:a16="http://schemas.microsoft.com/office/drawing/2014/main" id="{732EA836-29EF-4401-A195-E51EEB8B3A93}"/>
              </a:ext>
            </a:extLst>
          </p:cNvPr>
          <p:cNvGrpSpPr/>
          <p:nvPr/>
        </p:nvGrpSpPr>
        <p:grpSpPr>
          <a:xfrm>
            <a:off x="3582579" y="3063129"/>
            <a:ext cx="1071776" cy="821084"/>
            <a:chOff x="3072609" y="710200"/>
            <a:chExt cx="1071776" cy="821084"/>
          </a:xfrm>
        </p:grpSpPr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1CBD26CA-944E-0596-92A1-1E816777216F}"/>
                </a:ext>
              </a:extLst>
            </p:cNvPr>
            <p:cNvGrpSpPr/>
            <p:nvPr/>
          </p:nvGrpSpPr>
          <p:grpSpPr>
            <a:xfrm>
              <a:off x="3072609" y="710200"/>
              <a:ext cx="1071776" cy="821084"/>
              <a:chOff x="3072609" y="710200"/>
              <a:chExt cx="1071776" cy="821084"/>
            </a:xfrm>
          </p:grpSpPr>
          <p:grpSp>
            <p:nvGrpSpPr>
              <p:cNvPr id="199" name="Group 198">
                <a:extLst>
                  <a:ext uri="{FF2B5EF4-FFF2-40B4-BE49-F238E27FC236}">
                    <a16:creationId xmlns:a16="http://schemas.microsoft.com/office/drawing/2014/main" id="{6D4866DC-FB9B-8D52-F023-933D51A0A97A}"/>
                  </a:ext>
                </a:extLst>
              </p:cNvPr>
              <p:cNvGrpSpPr/>
              <p:nvPr/>
            </p:nvGrpSpPr>
            <p:grpSpPr>
              <a:xfrm>
                <a:off x="3072609" y="710200"/>
                <a:ext cx="1071776" cy="803529"/>
                <a:chOff x="3042783" y="7508855"/>
                <a:chExt cx="1293594" cy="969828"/>
              </a:xfrm>
            </p:grpSpPr>
            <p:sp>
              <p:nvSpPr>
                <p:cNvPr id="65" name="Rectangle 64">
                  <a:extLst>
                    <a:ext uri="{FF2B5EF4-FFF2-40B4-BE49-F238E27FC236}">
                      <a16:creationId xmlns:a16="http://schemas.microsoft.com/office/drawing/2014/main" id="{9310AD5F-BA6E-F0E5-F413-26943C7009F1}"/>
                    </a:ext>
                  </a:extLst>
                </p:cNvPr>
                <p:cNvSpPr/>
                <p:nvPr/>
              </p:nvSpPr>
              <p:spPr bwMode="auto">
                <a:xfrm>
                  <a:off x="3668142" y="8274913"/>
                  <a:ext cx="542782" cy="20377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497" dirty="0">
                      <a:latin typeface="Arial" panose="020B0604020202020204" pitchFamily="34" charset="0"/>
                      <a:ea typeface="Harding Text Web Regular" pitchFamily="2" charset="0"/>
                      <a:cs typeface="Arial" panose="020B0604020202020204" pitchFamily="34" charset="0"/>
                    </a:rPr>
                    <a:t>GAPDH</a:t>
                  </a:r>
                </a:p>
              </p:txBody>
            </p:sp>
            <p:sp>
              <p:nvSpPr>
                <p:cNvPr id="64" name="Rectangle 63">
                  <a:extLst>
                    <a:ext uri="{FF2B5EF4-FFF2-40B4-BE49-F238E27FC236}">
                      <a16:creationId xmlns:a16="http://schemas.microsoft.com/office/drawing/2014/main" id="{4C44708D-676B-A67A-2158-E3EE98F8543B}"/>
                    </a:ext>
                  </a:extLst>
                </p:cNvPr>
                <p:cNvSpPr/>
                <p:nvPr/>
              </p:nvSpPr>
              <p:spPr bwMode="auto">
                <a:xfrm>
                  <a:off x="3668142" y="7974941"/>
                  <a:ext cx="486743" cy="20377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497" dirty="0">
                      <a:latin typeface="Arial" panose="020B0604020202020204" pitchFamily="34" charset="0"/>
                      <a:ea typeface="Harding Text Web Regular" pitchFamily="2" charset="0"/>
                      <a:cs typeface="Arial" panose="020B0604020202020204" pitchFamily="34" charset="0"/>
                    </a:rPr>
                    <a:t>STIM2</a:t>
                  </a:r>
                </a:p>
              </p:txBody>
            </p:sp>
            <p:sp>
              <p:nvSpPr>
                <p:cNvPr id="81" name="Rectangle 80">
                  <a:extLst>
                    <a:ext uri="{FF2B5EF4-FFF2-40B4-BE49-F238E27FC236}">
                      <a16:creationId xmlns:a16="http://schemas.microsoft.com/office/drawing/2014/main" id="{F884778D-348F-E27E-7A74-82CC62C9D7AF}"/>
                    </a:ext>
                  </a:extLst>
                </p:cNvPr>
                <p:cNvSpPr/>
                <p:nvPr/>
              </p:nvSpPr>
              <p:spPr bwMode="auto">
                <a:xfrm rot="19168954">
                  <a:off x="3042783" y="7508855"/>
                  <a:ext cx="1047933" cy="20377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497" dirty="0">
                      <a:latin typeface="Arial" panose="020B0604020202020204" pitchFamily="34" charset="0"/>
                      <a:ea typeface="Harding Text Web Regular" pitchFamily="2" charset="0"/>
                      <a:cs typeface="Arial" panose="020B0604020202020204" pitchFamily="34" charset="0"/>
                    </a:rPr>
                    <a:t>Control</a:t>
                  </a:r>
                </a:p>
              </p:txBody>
            </p:sp>
            <p:sp>
              <p:nvSpPr>
                <p:cNvPr id="104" name="Rectangle 103">
                  <a:extLst>
                    <a:ext uri="{FF2B5EF4-FFF2-40B4-BE49-F238E27FC236}">
                      <a16:creationId xmlns:a16="http://schemas.microsoft.com/office/drawing/2014/main" id="{B2CF05CE-F7A6-A749-1F5E-B981772C7B92}"/>
                    </a:ext>
                  </a:extLst>
                </p:cNvPr>
                <p:cNvSpPr/>
                <p:nvPr/>
              </p:nvSpPr>
              <p:spPr bwMode="auto">
                <a:xfrm rot="19168954">
                  <a:off x="3316969" y="7518133"/>
                  <a:ext cx="1019408" cy="20377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r>
                    <a:rPr lang="en-US" sz="497" dirty="0">
                      <a:latin typeface="Arial" panose="020B0604020202020204" pitchFamily="34" charset="0"/>
                      <a:ea typeface="Harding Text Web Regular" pitchFamily="2" charset="0"/>
                      <a:cs typeface="Arial" panose="020B0604020202020204" pitchFamily="34" charset="0"/>
                    </a:rPr>
                    <a:t>STIM2-KO</a:t>
                  </a:r>
                </a:p>
              </p:txBody>
            </p:sp>
          </p:grpSp>
          <p:pic>
            <p:nvPicPr>
              <p:cNvPr id="15" name="Picture 14">
                <a:extLst>
                  <a:ext uri="{FF2B5EF4-FFF2-40B4-BE49-F238E27FC236}">
                    <a16:creationId xmlns:a16="http://schemas.microsoft.com/office/drawing/2014/main" id="{7E5DA96A-E0AC-BBB3-2C8A-8437B5758C2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rcRect l="47055" t="27148" r="42782" b="67124"/>
              <a:stretch>
                <a:fillRect/>
              </a:stretch>
            </p:blipFill>
            <p:spPr>
              <a:xfrm>
                <a:off x="3105118" y="1322496"/>
                <a:ext cx="520987" cy="208788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87382BDD-B108-D693-2E81-83406993585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l="47424" t="9068" r="43441" b="85783"/>
            <a:stretch>
              <a:fillRect/>
            </a:stretch>
          </p:blipFill>
          <p:spPr>
            <a:xfrm>
              <a:off x="3105118" y="1068395"/>
              <a:ext cx="520987" cy="20878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1F45CDBD-A25C-67D1-D3D8-0EBFEE7B6FD2}"/>
              </a:ext>
            </a:extLst>
          </p:cNvPr>
          <p:cNvGrpSpPr/>
          <p:nvPr/>
        </p:nvGrpSpPr>
        <p:grpSpPr>
          <a:xfrm>
            <a:off x="409438" y="1642312"/>
            <a:ext cx="1132113" cy="1097329"/>
            <a:chOff x="443749" y="2653054"/>
            <a:chExt cx="1132113" cy="1097329"/>
          </a:xfrm>
        </p:grpSpPr>
        <p:sp>
          <p:nvSpPr>
            <p:cNvPr id="99" name="Rectangle 98">
              <a:extLst>
                <a:ext uri="{FF2B5EF4-FFF2-40B4-BE49-F238E27FC236}">
                  <a16:creationId xmlns:a16="http://schemas.microsoft.com/office/drawing/2014/main" id="{6A16D628-C103-BD7D-276E-1BC9894337C5}"/>
                </a:ext>
              </a:extLst>
            </p:cNvPr>
            <p:cNvSpPr/>
            <p:nvPr/>
          </p:nvSpPr>
          <p:spPr bwMode="auto">
            <a:xfrm>
              <a:off x="986559" y="3292734"/>
              <a:ext cx="40327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STIM2</a:t>
              </a:r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46898FB6-7252-FE37-BE33-33308D02B110}"/>
                </a:ext>
              </a:extLst>
            </p:cNvPr>
            <p:cNvSpPr/>
            <p:nvPr/>
          </p:nvSpPr>
          <p:spPr bwMode="auto">
            <a:xfrm rot="19168954">
              <a:off x="443749" y="2659783"/>
              <a:ext cx="906024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BFABE168-49F3-F74D-2C6F-8E98CF0E89F0}"/>
                </a:ext>
              </a:extLst>
            </p:cNvPr>
            <p:cNvSpPr/>
            <p:nvPr/>
          </p:nvSpPr>
          <p:spPr bwMode="auto">
            <a:xfrm rot="19168954">
              <a:off x="683692" y="2653054"/>
              <a:ext cx="892170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STIM1/2-KO</a:t>
              </a: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id="{F9DB4611-DF45-4010-EEE2-74EB2156DF5A}"/>
                </a:ext>
              </a:extLst>
            </p:cNvPr>
            <p:cNvSpPr/>
            <p:nvPr/>
          </p:nvSpPr>
          <p:spPr bwMode="auto">
            <a:xfrm>
              <a:off x="986560" y="3055916"/>
              <a:ext cx="40327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STIM1</a:t>
              </a: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id="{62FF0973-40D9-629A-6ECE-7AA5AA0727B2}"/>
                </a:ext>
              </a:extLst>
            </p:cNvPr>
            <p:cNvSpPr/>
            <p:nvPr/>
          </p:nvSpPr>
          <p:spPr bwMode="auto">
            <a:xfrm>
              <a:off x="1000290" y="3532652"/>
              <a:ext cx="44970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GAPDH</a:t>
              </a:r>
            </a:p>
          </p:txBody>
        </p:sp>
        <p:pic>
          <p:nvPicPr>
            <p:cNvPr id="47" name="Picture 46">
              <a:extLst>
                <a:ext uri="{FF2B5EF4-FFF2-40B4-BE49-F238E27FC236}">
                  <a16:creationId xmlns:a16="http://schemas.microsoft.com/office/drawing/2014/main" id="{55C4741C-8CD4-9AD9-B1CC-A778518B37B0}"/>
                </a:ext>
              </a:extLst>
            </p:cNvPr>
            <p:cNvPicPr>
              <a:picLocks/>
            </p:cNvPicPr>
            <p:nvPr/>
          </p:nvPicPr>
          <p:blipFill>
            <a:blip r:embed="rId5"/>
            <a:srcRect l="60406" t="65184" r="29218" b="27141"/>
            <a:stretch>
              <a:fillRect/>
            </a:stretch>
          </p:blipFill>
          <p:spPr>
            <a:xfrm>
              <a:off x="499493" y="3048863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8" name="Picture 47">
              <a:extLst>
                <a:ext uri="{FF2B5EF4-FFF2-40B4-BE49-F238E27FC236}">
                  <a16:creationId xmlns:a16="http://schemas.microsoft.com/office/drawing/2014/main" id="{C9C5FA78-153F-E893-7865-76FC71844EBE}"/>
                </a:ext>
              </a:extLst>
            </p:cNvPr>
            <p:cNvPicPr>
              <a:picLocks/>
            </p:cNvPicPr>
            <p:nvPr/>
          </p:nvPicPr>
          <p:blipFill>
            <a:blip r:embed="rId6"/>
            <a:srcRect l="63349" t="29939" r="26461" b="62013"/>
            <a:stretch>
              <a:fillRect/>
            </a:stretch>
          </p:blipFill>
          <p:spPr>
            <a:xfrm>
              <a:off x="496690" y="3541583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8B971F14-1F5A-689E-4585-AC29284921C3}"/>
                </a:ext>
              </a:extLst>
            </p:cNvPr>
            <p:cNvPicPr>
              <a:picLocks/>
            </p:cNvPicPr>
            <p:nvPr/>
          </p:nvPicPr>
          <p:blipFill>
            <a:blip r:embed="rId5"/>
            <a:srcRect l="63471" t="18948" r="26451" b="77089"/>
            <a:stretch>
              <a:fillRect/>
            </a:stretch>
          </p:blipFill>
          <p:spPr>
            <a:xfrm>
              <a:off x="499493" y="3287736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50" name="Picture 49">
            <a:extLst>
              <a:ext uri="{FF2B5EF4-FFF2-40B4-BE49-F238E27FC236}">
                <a16:creationId xmlns:a16="http://schemas.microsoft.com/office/drawing/2014/main" id="{50633CB7-D7B4-D94C-EE3C-595EC52D8CD2}"/>
              </a:ext>
            </a:extLst>
          </p:cNvPr>
          <p:cNvPicPr>
            <a:picLocks/>
          </p:cNvPicPr>
          <p:nvPr/>
        </p:nvPicPr>
        <p:blipFill>
          <a:blip r:embed="rId7"/>
          <a:srcRect l="60426" t="58015" r="17350" b="30703"/>
          <a:stretch>
            <a:fillRect/>
          </a:stretch>
        </p:blipFill>
        <p:spPr>
          <a:xfrm>
            <a:off x="493598" y="1300992"/>
            <a:ext cx="522000" cy="2088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B5D81778-9F5F-D299-A8D2-D32EF8ED8B8D}"/>
              </a:ext>
            </a:extLst>
          </p:cNvPr>
          <p:cNvPicPr>
            <a:picLocks/>
          </p:cNvPicPr>
          <p:nvPr/>
        </p:nvPicPr>
        <p:blipFill>
          <a:blip r:embed="rId8"/>
          <a:srcRect l="13385" t="37358" r="67349" b="57285"/>
          <a:stretch>
            <a:fillRect/>
          </a:stretch>
        </p:blipFill>
        <p:spPr>
          <a:xfrm>
            <a:off x="493551" y="1043838"/>
            <a:ext cx="522000" cy="2088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36" name="Group 35">
            <a:extLst>
              <a:ext uri="{FF2B5EF4-FFF2-40B4-BE49-F238E27FC236}">
                <a16:creationId xmlns:a16="http://schemas.microsoft.com/office/drawing/2014/main" id="{F374033E-7E40-27CE-4405-10610FD016AE}"/>
              </a:ext>
            </a:extLst>
          </p:cNvPr>
          <p:cNvGrpSpPr/>
          <p:nvPr/>
        </p:nvGrpSpPr>
        <p:grpSpPr>
          <a:xfrm>
            <a:off x="381190" y="4277672"/>
            <a:ext cx="1091538" cy="793746"/>
            <a:chOff x="3031722" y="1639662"/>
            <a:chExt cx="1091538" cy="793746"/>
          </a:xfrm>
        </p:grpSpPr>
        <p:grpSp>
          <p:nvGrpSpPr>
            <p:cNvPr id="219" name="Group 218">
              <a:extLst>
                <a:ext uri="{FF2B5EF4-FFF2-40B4-BE49-F238E27FC236}">
                  <a16:creationId xmlns:a16="http://schemas.microsoft.com/office/drawing/2014/main" id="{A69C6FE2-E7F1-80DE-4225-E87977E2442A}"/>
                </a:ext>
              </a:extLst>
            </p:cNvPr>
            <p:cNvGrpSpPr/>
            <p:nvPr/>
          </p:nvGrpSpPr>
          <p:grpSpPr>
            <a:xfrm>
              <a:off x="3031722" y="1639662"/>
              <a:ext cx="1091538" cy="761021"/>
              <a:chOff x="3343347" y="7510985"/>
              <a:chExt cx="1317446" cy="918526"/>
            </a:xfrm>
          </p:grpSpPr>
          <p:sp>
            <p:nvSpPr>
              <p:cNvPr id="204" name="Rectangle 203">
                <a:extLst>
                  <a:ext uri="{FF2B5EF4-FFF2-40B4-BE49-F238E27FC236}">
                    <a16:creationId xmlns:a16="http://schemas.microsoft.com/office/drawing/2014/main" id="{EF784C2F-88FC-EAC4-2FE9-2F0DA176E1A6}"/>
                  </a:ext>
                </a:extLst>
              </p:cNvPr>
              <p:cNvSpPr/>
              <p:nvPr/>
            </p:nvSpPr>
            <p:spPr bwMode="auto">
              <a:xfrm>
                <a:off x="4051370" y="7956331"/>
                <a:ext cx="486743" cy="2037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ORAI2</a:t>
                </a:r>
              </a:p>
            </p:txBody>
          </p:sp>
          <p:sp>
            <p:nvSpPr>
              <p:cNvPr id="205" name="Rectangle 204">
                <a:extLst>
                  <a:ext uri="{FF2B5EF4-FFF2-40B4-BE49-F238E27FC236}">
                    <a16:creationId xmlns:a16="http://schemas.microsoft.com/office/drawing/2014/main" id="{C4C6D136-2CD3-DD46-D83E-3A48CE60BF8C}"/>
                  </a:ext>
                </a:extLst>
              </p:cNvPr>
              <p:cNvSpPr/>
              <p:nvPr/>
            </p:nvSpPr>
            <p:spPr bwMode="auto">
              <a:xfrm>
                <a:off x="4061981" y="8225740"/>
                <a:ext cx="542782" cy="2037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211" name="Rectangle 210">
                <a:extLst>
                  <a:ext uri="{FF2B5EF4-FFF2-40B4-BE49-F238E27FC236}">
                    <a16:creationId xmlns:a16="http://schemas.microsoft.com/office/drawing/2014/main" id="{4238BC58-18C5-8AEF-276F-D09EA4D6586F}"/>
                  </a:ext>
                </a:extLst>
              </p:cNvPr>
              <p:cNvSpPr/>
              <p:nvPr/>
            </p:nvSpPr>
            <p:spPr bwMode="auto">
              <a:xfrm rot="19168954">
                <a:off x="3343347" y="7510985"/>
                <a:ext cx="1047933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ORAI2</a:t>
                </a:r>
                <a:r>
                  <a:rPr lang="en-US" sz="497" baseline="30000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LysM-Cre-</a:t>
                </a:r>
                <a:endPara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Rectangle 212">
                <a:extLst>
                  <a:ext uri="{FF2B5EF4-FFF2-40B4-BE49-F238E27FC236}">
                    <a16:creationId xmlns:a16="http://schemas.microsoft.com/office/drawing/2014/main" id="{22510909-A69F-1799-6930-B6E4DF17E21A}"/>
                  </a:ext>
                </a:extLst>
              </p:cNvPr>
              <p:cNvSpPr/>
              <p:nvPr/>
            </p:nvSpPr>
            <p:spPr bwMode="auto">
              <a:xfrm rot="19168954">
                <a:off x="3641385" y="7520253"/>
                <a:ext cx="1019408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ORAI2</a:t>
                </a:r>
                <a:r>
                  <a:rPr lang="en-US" sz="497" baseline="30000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LysM-Cre+</a:t>
                </a:r>
                <a:endPara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2" name="Picture 71">
              <a:extLst>
                <a:ext uri="{FF2B5EF4-FFF2-40B4-BE49-F238E27FC236}">
                  <a16:creationId xmlns:a16="http://schemas.microsoft.com/office/drawing/2014/main" id="{F0EF2EE5-A1D7-0EA5-AE3F-789F94EB6C65}"/>
                </a:ext>
              </a:extLst>
            </p:cNvPr>
            <p:cNvPicPr>
              <a:picLocks/>
            </p:cNvPicPr>
            <p:nvPr/>
          </p:nvPicPr>
          <p:blipFill>
            <a:blip r:embed="rId3"/>
            <a:srcRect l="47357" t="27692" r="42554" b="64260"/>
            <a:stretch>
              <a:fillRect/>
            </a:stretch>
          </p:blipFill>
          <p:spPr>
            <a:xfrm>
              <a:off x="3100144" y="2224608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3" name="Picture 72">
              <a:extLst>
                <a:ext uri="{FF2B5EF4-FFF2-40B4-BE49-F238E27FC236}">
                  <a16:creationId xmlns:a16="http://schemas.microsoft.com/office/drawing/2014/main" id="{D4DA8B7A-7942-32A6-9DE9-1F66A8AA1CDA}"/>
                </a:ext>
              </a:extLst>
            </p:cNvPr>
            <p:cNvPicPr>
              <a:picLocks/>
            </p:cNvPicPr>
            <p:nvPr/>
          </p:nvPicPr>
          <p:blipFill>
            <a:blip r:embed="rId3"/>
            <a:srcRect l="60902" t="78053" r="29009" b="13899"/>
            <a:stretch>
              <a:fillRect/>
            </a:stretch>
          </p:blipFill>
          <p:spPr>
            <a:xfrm>
              <a:off x="3104027" y="1979944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26" name="Group 25">
            <a:extLst>
              <a:ext uri="{FF2B5EF4-FFF2-40B4-BE49-F238E27FC236}">
                <a16:creationId xmlns:a16="http://schemas.microsoft.com/office/drawing/2014/main" id="{A9C87CDF-285A-F0A9-9F25-4E2A5D1C4AF0}"/>
              </a:ext>
            </a:extLst>
          </p:cNvPr>
          <p:cNvGrpSpPr/>
          <p:nvPr/>
        </p:nvGrpSpPr>
        <p:grpSpPr>
          <a:xfrm>
            <a:off x="4503984" y="1653841"/>
            <a:ext cx="1150154" cy="1060722"/>
            <a:chOff x="400452" y="4014005"/>
            <a:chExt cx="1150154" cy="1060722"/>
          </a:xfrm>
        </p:grpSpPr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BD12D06C-EB1F-5B2D-4B2A-E36B7EBED0FA}"/>
                </a:ext>
              </a:extLst>
            </p:cNvPr>
            <p:cNvSpPr/>
            <p:nvPr/>
          </p:nvSpPr>
          <p:spPr bwMode="auto">
            <a:xfrm>
              <a:off x="991729" y="4383404"/>
              <a:ext cx="40327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STIM1</a:t>
              </a:r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6839A5DA-FF64-CB04-9784-68B632AA4AC5}"/>
                </a:ext>
              </a:extLst>
            </p:cNvPr>
            <p:cNvSpPr/>
            <p:nvPr/>
          </p:nvSpPr>
          <p:spPr bwMode="auto">
            <a:xfrm>
              <a:off x="1000290" y="4883200"/>
              <a:ext cx="44970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GAPDH</a:t>
              </a:r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5C4DEFD7-CFCE-FB02-7CB9-2C03C66CEA62}"/>
                </a:ext>
              </a:extLst>
            </p:cNvPr>
            <p:cNvSpPr/>
            <p:nvPr/>
          </p:nvSpPr>
          <p:spPr bwMode="auto">
            <a:xfrm rot="19168954">
              <a:off x="400452" y="4014005"/>
              <a:ext cx="903063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Control</a:t>
              </a:r>
            </a:p>
          </p:txBody>
        </p:sp>
        <p:sp>
          <p:nvSpPr>
            <p:cNvPr id="130" name="Rectangle 129">
              <a:extLst>
                <a:ext uri="{FF2B5EF4-FFF2-40B4-BE49-F238E27FC236}">
                  <a16:creationId xmlns:a16="http://schemas.microsoft.com/office/drawing/2014/main" id="{583C7ABB-279B-3866-0B1B-61346B2ECCBB}"/>
                </a:ext>
              </a:extLst>
            </p:cNvPr>
            <p:cNvSpPr/>
            <p:nvPr/>
          </p:nvSpPr>
          <p:spPr bwMode="auto">
            <a:xfrm rot="19168954">
              <a:off x="660458" y="4038406"/>
              <a:ext cx="890148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STIM1/ORAI1-KO</a:t>
              </a: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3F70880B-342A-3779-4C2D-EA92AF5A24E1}"/>
                </a:ext>
              </a:extLst>
            </p:cNvPr>
            <p:cNvSpPr/>
            <p:nvPr/>
          </p:nvSpPr>
          <p:spPr bwMode="auto">
            <a:xfrm>
              <a:off x="1007330" y="4639044"/>
              <a:ext cx="403279" cy="16882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497" dirty="0">
                  <a:latin typeface="Arial" panose="020B0604020202020204" pitchFamily="34" charset="0"/>
                  <a:ea typeface="Harding Text Web Regular" pitchFamily="2" charset="0"/>
                  <a:cs typeface="Arial" panose="020B0604020202020204" pitchFamily="34" charset="0"/>
                </a:rPr>
                <a:t>ORAI1</a:t>
              </a:r>
            </a:p>
          </p:txBody>
        </p:sp>
        <p:pic>
          <p:nvPicPr>
            <p:cNvPr id="129" name="Picture 128">
              <a:extLst>
                <a:ext uri="{FF2B5EF4-FFF2-40B4-BE49-F238E27FC236}">
                  <a16:creationId xmlns:a16="http://schemas.microsoft.com/office/drawing/2014/main" id="{D8020B06-5CA9-D7FF-E641-13781EF2B869}"/>
                </a:ext>
              </a:extLst>
            </p:cNvPr>
            <p:cNvPicPr>
              <a:picLocks/>
            </p:cNvPicPr>
            <p:nvPr/>
          </p:nvPicPr>
          <p:blipFill>
            <a:blip r:embed="rId5"/>
            <a:srcRect l="41709" t="20278" r="48594" b="75336"/>
            <a:stretch>
              <a:fillRect/>
            </a:stretch>
          </p:blipFill>
          <p:spPr>
            <a:xfrm>
              <a:off x="478958" y="4384738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5" name="Picture 134">
              <a:extLst>
                <a:ext uri="{FF2B5EF4-FFF2-40B4-BE49-F238E27FC236}">
                  <a16:creationId xmlns:a16="http://schemas.microsoft.com/office/drawing/2014/main" id="{5F01B80D-331A-6E9A-6523-240A3A3E98F3}"/>
                </a:ext>
              </a:extLst>
            </p:cNvPr>
            <p:cNvPicPr>
              <a:picLocks/>
            </p:cNvPicPr>
            <p:nvPr/>
          </p:nvPicPr>
          <p:blipFill>
            <a:blip r:embed="rId6"/>
            <a:srcRect l="38533" t="75861" r="51080" b="16106"/>
            <a:stretch>
              <a:fillRect/>
            </a:stretch>
          </p:blipFill>
          <p:spPr>
            <a:xfrm>
              <a:off x="481850" y="4623322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36" name="Picture 135">
              <a:extLst>
                <a:ext uri="{FF2B5EF4-FFF2-40B4-BE49-F238E27FC236}">
                  <a16:creationId xmlns:a16="http://schemas.microsoft.com/office/drawing/2014/main" id="{E3B1E077-A4E0-0709-6707-8BEB6765790C}"/>
                </a:ext>
              </a:extLst>
            </p:cNvPr>
            <p:cNvPicPr>
              <a:picLocks/>
            </p:cNvPicPr>
            <p:nvPr/>
          </p:nvPicPr>
          <p:blipFill>
            <a:blip r:embed="rId9"/>
            <a:srcRect l="41532" t="33233" r="48188" b="60752"/>
            <a:stretch>
              <a:fillRect/>
            </a:stretch>
          </p:blipFill>
          <p:spPr>
            <a:xfrm>
              <a:off x="483379" y="4865927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FA7FC7D7-62D4-C1D8-8C18-3D6579064713}"/>
              </a:ext>
            </a:extLst>
          </p:cNvPr>
          <p:cNvGrpSpPr/>
          <p:nvPr/>
        </p:nvGrpSpPr>
        <p:grpSpPr>
          <a:xfrm>
            <a:off x="3141812" y="727548"/>
            <a:ext cx="1098265" cy="879794"/>
            <a:chOff x="381494" y="1590385"/>
            <a:chExt cx="1098265" cy="879794"/>
          </a:xfrm>
        </p:grpSpPr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2102291C-BB68-D9C9-BFE7-79D42BC35D4D}"/>
                </a:ext>
              </a:extLst>
            </p:cNvPr>
            <p:cNvGrpSpPr/>
            <p:nvPr/>
          </p:nvGrpSpPr>
          <p:grpSpPr>
            <a:xfrm>
              <a:off x="381494" y="1590385"/>
              <a:ext cx="1098265" cy="855155"/>
              <a:chOff x="256733" y="4828427"/>
              <a:chExt cx="1325563" cy="1032140"/>
            </a:xfrm>
          </p:grpSpPr>
          <p:sp>
            <p:nvSpPr>
              <p:cNvPr id="138" name="Rectangle 137">
                <a:extLst>
                  <a:ext uri="{FF2B5EF4-FFF2-40B4-BE49-F238E27FC236}">
                    <a16:creationId xmlns:a16="http://schemas.microsoft.com/office/drawing/2014/main" id="{B4144CAD-2CD0-3CC8-EAFD-3F0DD70E2524}"/>
                  </a:ext>
                </a:extLst>
              </p:cNvPr>
              <p:cNvSpPr/>
              <p:nvPr/>
            </p:nvSpPr>
            <p:spPr bwMode="auto">
              <a:xfrm>
                <a:off x="941263" y="5292445"/>
                <a:ext cx="486741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ORAI1</a:t>
                </a:r>
              </a:p>
            </p:txBody>
          </p:sp>
          <p:sp>
            <p:nvSpPr>
              <p:cNvPr id="139" name="Rectangle 138">
                <a:extLst>
                  <a:ext uri="{FF2B5EF4-FFF2-40B4-BE49-F238E27FC236}">
                    <a16:creationId xmlns:a16="http://schemas.microsoft.com/office/drawing/2014/main" id="{2B569262-270C-F360-D4A7-10DAFD89717A}"/>
                  </a:ext>
                </a:extLst>
              </p:cNvPr>
              <p:cNvSpPr/>
              <p:nvPr/>
            </p:nvSpPr>
            <p:spPr bwMode="auto">
              <a:xfrm>
                <a:off x="935696" y="5656797"/>
                <a:ext cx="542779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GAPDH</a:t>
                </a:r>
              </a:p>
            </p:txBody>
          </p:sp>
          <p:sp>
            <p:nvSpPr>
              <p:cNvPr id="145" name="Rectangle 144">
                <a:extLst>
                  <a:ext uri="{FF2B5EF4-FFF2-40B4-BE49-F238E27FC236}">
                    <a16:creationId xmlns:a16="http://schemas.microsoft.com/office/drawing/2014/main" id="{3A332523-E795-CA2C-44C6-8BFB2C0AD330}"/>
                  </a:ext>
                </a:extLst>
              </p:cNvPr>
              <p:cNvSpPr/>
              <p:nvPr/>
            </p:nvSpPr>
            <p:spPr bwMode="auto">
              <a:xfrm rot="19168954">
                <a:off x="256733" y="4828427"/>
                <a:ext cx="1047933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sp>
            <p:nvSpPr>
              <p:cNvPr id="147" name="Rectangle 146">
                <a:extLst>
                  <a:ext uri="{FF2B5EF4-FFF2-40B4-BE49-F238E27FC236}">
                    <a16:creationId xmlns:a16="http://schemas.microsoft.com/office/drawing/2014/main" id="{395ECAE1-FDD3-D4A4-B2DE-6FD947F03800}"/>
                  </a:ext>
                </a:extLst>
              </p:cNvPr>
              <p:cNvSpPr/>
              <p:nvPr/>
            </p:nvSpPr>
            <p:spPr bwMode="auto">
              <a:xfrm rot="19168954">
                <a:off x="562888" y="4843192"/>
                <a:ext cx="1019408" cy="203770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r>
                  <a:rPr lang="en-US" sz="497" dirty="0">
                    <a:latin typeface="Arial" panose="020B0604020202020204" pitchFamily="34" charset="0"/>
                    <a:ea typeface="Harding Text Web Regular" pitchFamily="2" charset="0"/>
                    <a:cs typeface="Arial" panose="020B0604020202020204" pitchFamily="34" charset="0"/>
                  </a:rPr>
                  <a:t>ORAI1-KO</a:t>
                </a:r>
              </a:p>
            </p:txBody>
          </p:sp>
        </p:grpSp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B4537C2-572F-3741-50D2-F8F0CA16828A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rcRect l="37273" t="17585" r="48847" b="72255"/>
            <a:stretch>
              <a:fillRect/>
            </a:stretch>
          </p:blipFill>
          <p:spPr>
            <a:xfrm>
              <a:off x="499493" y="1961138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8AC3806-6F7E-3610-BD1C-212C705C02FD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rcRect l="39020" t="76179" r="47380" b="12252"/>
            <a:stretch>
              <a:fillRect/>
            </a:stretch>
          </p:blipFill>
          <p:spPr>
            <a:xfrm>
              <a:off x="492457" y="2261379"/>
              <a:ext cx="522000" cy="208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pic>
        <p:nvPicPr>
          <p:cNvPr id="39" name="Picture 38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E6378188-A8CA-E08B-A5AC-3F0119142D6D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302149" y="683134"/>
            <a:ext cx="1323855" cy="935828"/>
          </a:xfrm>
          <a:prstGeom prst="rect">
            <a:avLst/>
          </a:prstGeom>
        </p:spPr>
      </p:pic>
      <p:pic>
        <p:nvPicPr>
          <p:cNvPr id="46" name="Picture 45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146E9A17-450B-926D-6281-E52F58117C15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926018" y="3125920"/>
            <a:ext cx="1540693" cy="935828"/>
          </a:xfrm>
          <a:prstGeom prst="rect">
            <a:avLst/>
          </a:prstGeom>
        </p:spPr>
      </p:pic>
      <p:pic>
        <p:nvPicPr>
          <p:cNvPr id="54" name="Picture 53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AA6BE983-2AB7-F3B6-237A-9EA3B92CBDC1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899440" y="4322342"/>
            <a:ext cx="1323855" cy="935828"/>
          </a:xfrm>
          <a:prstGeom prst="rect">
            <a:avLst/>
          </a:prstGeom>
        </p:spPr>
      </p:pic>
      <p:pic>
        <p:nvPicPr>
          <p:cNvPr id="56" name="Picture 55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1F0FE5AC-F7B7-9D40-1787-D1FDA569EF2D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617504" y="687864"/>
            <a:ext cx="1363798" cy="935828"/>
          </a:xfrm>
          <a:prstGeom prst="rect">
            <a:avLst/>
          </a:prstGeom>
        </p:spPr>
      </p:pic>
      <p:pic>
        <p:nvPicPr>
          <p:cNvPr id="59" name="Picture 58" descr="A pixelated image of a person's face&#10;&#10;AI-generated content may be incorrect.">
            <a:extLst>
              <a:ext uri="{FF2B5EF4-FFF2-40B4-BE49-F238E27FC236}">
                <a16:creationId xmlns:a16="http://schemas.microsoft.com/office/drawing/2014/main" id="{10097DE8-4768-0A72-BB21-348B7EC82A8B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618912" y="1855732"/>
            <a:ext cx="1335267" cy="930122"/>
          </a:xfrm>
          <a:prstGeom prst="rect">
            <a:avLst/>
          </a:prstGeom>
        </p:spPr>
      </p:pic>
      <p:pic>
        <p:nvPicPr>
          <p:cNvPr id="61" name="Picture 60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A358F730-8A1A-14F4-92B3-9BD0ED7912B1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65904" y="3125920"/>
            <a:ext cx="1540693" cy="935828"/>
          </a:xfrm>
          <a:prstGeom prst="rect">
            <a:avLst/>
          </a:prstGeom>
        </p:spPr>
      </p:pic>
      <p:pic>
        <p:nvPicPr>
          <p:cNvPr id="63" name="Picture 62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A7D4F1A6-B2BE-78B1-9FC4-169A090FAC1C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650385" y="3125920"/>
            <a:ext cx="1301029" cy="935828"/>
          </a:xfrm>
          <a:prstGeom prst="rect">
            <a:avLst/>
          </a:prstGeom>
        </p:spPr>
      </p:pic>
      <p:pic>
        <p:nvPicPr>
          <p:cNvPr id="67" name="Picture 66" descr="A screenshot of a video game&#10;&#10;AI-generated content may be incorrect.">
            <a:extLst>
              <a:ext uri="{FF2B5EF4-FFF2-40B4-BE49-F238E27FC236}">
                <a16:creationId xmlns:a16="http://schemas.microsoft.com/office/drawing/2014/main" id="{2B434335-3631-F309-F760-6B72F519447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987700" y="1842863"/>
            <a:ext cx="1363798" cy="9358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96032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8A9822BF-9ECA-149B-2131-AA404591EA5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8F0DF5BC-0CE2-2B2E-3C04-744CDBE72615}"/>
              </a:ext>
            </a:extLst>
          </p:cNvPr>
          <p:cNvSpPr txBox="1"/>
          <p:nvPr/>
        </p:nvSpPr>
        <p:spPr>
          <a:xfrm>
            <a:off x="688181" y="713968"/>
            <a:ext cx="4660540" cy="283590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994" b="1" dirty="0" smtClean="0">
                <a:latin typeface="Arial" panose="020B0604020202020204" pitchFamily="34" charset="0"/>
                <a:ea typeface="Calibri" panose="020F0502020204030204" pitchFamily="34" charset="0"/>
              </a:rPr>
              <a:t>Supplemental Fig</a:t>
            </a:r>
            <a:r>
              <a:rPr lang="en-US" sz="994" b="1" dirty="0">
                <a:latin typeface="Arial" panose="020B0604020202020204" pitchFamily="34" charset="0"/>
                <a:ea typeface="Calibri" panose="020F0502020204030204" pitchFamily="34" charset="0"/>
              </a:rPr>
              <a:t>. </a:t>
            </a:r>
            <a:r>
              <a:rPr lang="en-US" sz="994" b="1" dirty="0" smtClean="0">
                <a:latin typeface="Arial" panose="020B0604020202020204" pitchFamily="34" charset="0"/>
                <a:ea typeface="Calibri" panose="020F0502020204030204" pitchFamily="34" charset="0"/>
              </a:rPr>
              <a:t>1 </a:t>
            </a:r>
            <a:r>
              <a:rPr lang="en-US" sz="994" b="1" dirty="0">
                <a:latin typeface="Arial" panose="020B0604020202020204" pitchFamily="34" charset="0"/>
                <a:ea typeface="Calibri" panose="020F0502020204030204" pitchFamily="34" charset="0"/>
              </a:rPr>
              <a:t>Expression of Ca</a:t>
            </a:r>
            <a:r>
              <a:rPr lang="en-US" sz="994" b="1" baseline="30000" dirty="0">
                <a:latin typeface="Arial" panose="020B0604020202020204" pitchFamily="34" charset="0"/>
                <a:ea typeface="Calibri" panose="020F0502020204030204" pitchFamily="34" charset="0"/>
              </a:rPr>
              <a:t>2+</a:t>
            </a:r>
            <a:r>
              <a:rPr lang="en-US" sz="994" b="1" dirty="0">
                <a:latin typeface="Arial" panose="020B0604020202020204" pitchFamily="34" charset="0"/>
                <a:ea typeface="Calibri" panose="020F0502020204030204" pitchFamily="34" charset="0"/>
              </a:rPr>
              <a:t> isoforms in neutrophils.</a:t>
            </a:r>
            <a:r>
              <a:rPr lang="en-US" sz="99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DE" sz="990" dirty="0">
                <a:latin typeface="Arial" panose="020B0604020202020204" pitchFamily="34" charset="0"/>
                <a:cs typeface="Arial" panose="020B0604020202020204" pitchFamily="34" charset="0"/>
              </a:rPr>
              <a:t>Determination of Ca</a:t>
            </a:r>
            <a:r>
              <a:rPr lang="en-DE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2+</a:t>
            </a:r>
            <a:r>
              <a:rPr lang="en-DE" sz="990" dirty="0">
                <a:latin typeface="Arial" panose="020B0604020202020204" pitchFamily="34" charset="0"/>
                <a:cs typeface="Arial" panose="020B0604020202020204" pitchFamily="34" charset="0"/>
              </a:rPr>
              <a:t> isoforms via immunoblotting from control and 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STIM1-KO = STIM1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ORAI1-KO =ORAI1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STIM1/2-KO = STIM1/2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STIM1/ORAI1-KO = STIM1/ORAI1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STIM2-KO = STIM2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  and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ORAI2-KO = ORAI2</a:t>
            </a:r>
            <a:r>
              <a:rPr lang="en-US" sz="990" baseline="30000" dirty="0">
                <a:latin typeface="Arial" panose="020B0604020202020204" pitchFamily="34" charset="0"/>
                <a:cs typeface="Arial" panose="020B0604020202020204" pitchFamily="34" charset="0"/>
              </a:rPr>
              <a:t>LysM-Cre+</a:t>
            </a:r>
            <a:r>
              <a:rPr lang="en-DE" sz="990" dirty="0">
                <a:latin typeface="Arial" panose="020B0604020202020204" pitchFamily="34" charset="0"/>
                <a:cs typeface="Arial" panose="020B0604020202020204" pitchFamily="34" charset="0"/>
              </a:rPr>
              <a:t> neutrophils. 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Lysates were immunoblotted with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 E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 H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anti-STIM1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anti-ORAI1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anti-STIM2, (</a:t>
            </a:r>
            <a:r>
              <a:rPr lang="en-US" sz="99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) anti-ORAI2 and (</a:t>
            </a:r>
            <a:r>
              <a:rPr lang="en-US" sz="990" b="1" dirty="0" smtClean="0">
                <a:latin typeface="Arial" panose="020B0604020202020204" pitchFamily="34" charset="0"/>
                <a:cs typeface="Arial" panose="020B0604020202020204" pitchFamily="34" charset="0"/>
              </a:rPr>
              <a:t>A, C, E, H, K, M</a:t>
            </a:r>
            <a:r>
              <a:rPr lang="en-US" sz="99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990" dirty="0">
                <a:latin typeface="Arial" panose="020B0604020202020204" pitchFamily="34" charset="0"/>
                <a:cs typeface="Arial" panose="020B0604020202020204" pitchFamily="34" charset="0"/>
              </a:rPr>
              <a:t>anti-GAPDH, n=3, experimental repeat. Representative western blot images are cropped. Data are mean </a:t>
            </a:r>
            <a:r>
              <a:rPr lang="en-GB" sz="990" dirty="0">
                <a:latin typeface="Arial" panose="020B0604020202020204" pitchFamily="34" charset="0"/>
                <a:cs typeface="Arial" panose="020B0604020202020204" pitchFamily="34" charset="0"/>
              </a:rPr>
              <a:t>± SEM. *p&lt;0.05, **p&lt;0.01, ****p&lt;0.0001 by one-way ANOVA.</a:t>
            </a:r>
            <a:r>
              <a:rPr lang="en-DE" sz="99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DE" sz="99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75944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200</Words>
  <Application>Microsoft Office PowerPoint</Application>
  <PresentationFormat>Benutzerdefiniert</PresentationFormat>
  <Paragraphs>44</Paragraphs>
  <Slides>2</Slides>
  <Notes>2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Harding Text Web Regular</vt:lpstr>
      <vt:lpstr>Office 2013 - 2022 Theme</vt:lpstr>
      <vt:lpstr>Supplemental Fig. 1. Expression of Ca2+ isoforms in neutrophils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lcium figure file</dc:title>
  <dc:creator>Marina Kardell</dc:creator>
  <cp:lastModifiedBy>Cappenberg</cp:lastModifiedBy>
  <cp:revision>204</cp:revision>
  <dcterms:created xsi:type="dcterms:W3CDTF">2023-11-02T11:54:21Z</dcterms:created>
  <dcterms:modified xsi:type="dcterms:W3CDTF">2025-12-23T08:08:37Z</dcterms:modified>
</cp:coreProperties>
</file>